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</p:sldIdLst>
  <p:sldSz cx="12192000" cy="6858000"/>
  <p:notesSz cx="6858000" cy="9144000"/>
  <p:defaultTextStyle>
    <a:defPPr>
      <a:defRPr lang="en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6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20781-531E-6FE8-BE99-3E84D628AD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61B1B9-CAF8-AECD-3AA4-125EB71977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671A14-5D33-8F8A-4A7A-B04DC03EE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3E9453-F0A5-7055-E2F3-8B7F6F5AB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A35D39-1E0B-8BEB-3338-56F39DA3E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275051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4937B-2533-E305-24AA-FF421FBCF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C4F219-3E65-8367-2D98-034E7171A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5298BA-B02C-B41D-B41C-65FC779AB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9FCB3-E40A-AE6D-E952-B966A33E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2C684D-6F07-4E2F-31FF-484FDA89C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56105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E9F0F9-5E2B-849E-CFB8-2EB423A94E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627D52-C682-82CD-7907-8F469B97EC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272F6-3FED-7683-E030-B490C9265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B1E926-7BF4-4E86-B76C-56F9B9602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4D2E1-3002-5B13-BAE1-CA6C159F2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9908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E5EE3-90FB-AAA2-88F9-08B5B5AFA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814DA7-3F05-3383-3CC9-F677475120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7C1B43-F180-07CD-825C-1780EA3B8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AEFF9-B772-711C-652D-B40E820CE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B6C64-A6A9-FB2F-9C0B-E222F669B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200039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103F8-12BD-5701-BC08-564C92E50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EFDF7E-B68F-C10A-A050-1A4990F635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FB08F3-11BC-8D50-A1E2-8820F24C7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D7A8A-9C31-B3BA-3534-3F8D8DDB2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0C729-2EB7-513E-C044-060107BC0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420138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954D7-ACDE-4506-C27C-979F788743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F25E60-4FC8-43E1-12A5-CD370068B8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AF85D8-185E-F429-FA2F-8F667693A5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03D5B3-3AA0-8254-10F4-C8CEEDA64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E631EE-F224-2CFE-C74F-984C24407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C812C-339D-ED43-DA17-2287601CA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72294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0859D-DC5E-9B3A-322A-92D283E0C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0A2C-A98F-A7D4-E28E-3A29E20FB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E5373E-8CF1-6A5E-7029-700EFF87CB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03967E-69C5-5825-EEB8-2DA7A8944B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B48709-93AB-4BFB-247A-763B1ADC16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1F8EE7-6287-B132-C716-85E2DB94F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371202-0F77-585C-6907-927D2CB1B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42FA8F-0C96-72AE-7F81-B695A06D3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681947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C094E-ED88-81FE-C5C9-67D0D6A9E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321486-102A-0955-3C7B-32C107023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0AA438-4827-43C6-127D-571C97F0D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FF4842-1C81-7EE1-ED54-6B0FD261A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40627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4DD78A-8574-5741-F391-CEEC437E2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B0BD34-972A-CFEB-AA3F-0A297A320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369967-AE73-D221-8C64-941F4442D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96020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3E44DE-86BE-17DC-71C7-B07AC18FC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EC0CEC-B1FE-CBA6-A2D0-838CE1DCE1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BA2628-A55E-4696-2CE7-22A0AEBD32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1A8F6A-0E35-3812-4C24-AC9AEC990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9CF4A5-5A15-584E-425B-731D42634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0F4E7E-AD64-7F67-9F7A-624D6707C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21499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4F3F60-6CC5-C14F-3718-6B455B662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D07B53-DC42-1CFF-21F0-5E2A81ABE6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68EDAC-D140-0443-F7F3-85ED43ABF9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EFD94-8648-7950-BF30-3BF7F0232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794A52-5588-D305-5DFA-484DF66A3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922961-C53B-F172-C0AE-FA9F9A763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95050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9A1F8A-E514-BEC1-5710-31F7966CB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9C46DC-9BE7-99B9-0019-E13D2E453C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7595DF-FAD8-6A09-916D-68FAF54300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F31B7-1FD8-44BC-BAB0-D5715D56BAEB}" type="datetimeFigureOut">
              <a:rPr lang="en-IL" smtClean="0"/>
              <a:t>16/11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EEA915-C71C-B236-6AB1-62C001B0EF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31D14D-E2CD-5AFC-0966-6256F8E990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ED54D-8406-4A9D-9B63-A368E98964EA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78064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1.png"/><Relationship Id="rId7" Type="http://schemas.openxmlformats.org/officeDocument/2006/relationships/image" Target="../media/image14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7.png"/><Relationship Id="rId5" Type="http://schemas.microsoft.com/office/2007/relationships/hdphoto" Target="../media/hdphoto3.wdp"/><Relationship Id="rId10" Type="http://schemas.microsoft.com/office/2007/relationships/hdphoto" Target="../media/hdphoto4.wdp"/><Relationship Id="rId4" Type="http://schemas.openxmlformats.org/officeDocument/2006/relationships/image" Target="../media/image12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microsoft.com/office/2007/relationships/hdphoto" Target="../media/hdphoto5.wdp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5BD42B3-1B29-CC0B-BA63-97EB4567DD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440" t="46925" r="23873" b="43720"/>
          <a:stretch/>
        </p:blipFill>
        <p:spPr>
          <a:xfrm>
            <a:off x="768060" y="3570536"/>
            <a:ext cx="4682339" cy="4769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354479C-F1E7-5272-B33A-0041AD53A90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898" t="29613" r="23235" b="37061"/>
          <a:stretch/>
        </p:blipFill>
        <p:spPr>
          <a:xfrm>
            <a:off x="768060" y="1985639"/>
            <a:ext cx="4682339" cy="6958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13DEB7F-F1BD-6582-4969-2FDA183BBA39}"/>
              </a:ext>
            </a:extLst>
          </p:cNvPr>
          <p:cNvSpPr txBox="1"/>
          <p:nvPr/>
        </p:nvSpPr>
        <p:spPr>
          <a:xfrm>
            <a:off x="66585" y="3622090"/>
            <a:ext cx="736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3214DA-5600-8EB4-9BD6-F8EF4DF1657C}"/>
              </a:ext>
            </a:extLst>
          </p:cNvPr>
          <p:cNvSpPr txBox="1"/>
          <p:nvPr/>
        </p:nvSpPr>
        <p:spPr>
          <a:xfrm>
            <a:off x="334685" y="1839043"/>
            <a:ext cx="736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545D21E-5034-63AA-D08B-F4764B84B42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792" t="36037" r="22394" b="47660"/>
          <a:stretch/>
        </p:blipFill>
        <p:spPr>
          <a:xfrm>
            <a:off x="769651" y="1228688"/>
            <a:ext cx="4682339" cy="6854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C50B24F8-5ED2-493B-D186-E44EF9A4D324}"/>
              </a:ext>
            </a:extLst>
          </p:cNvPr>
          <p:cNvSpPr txBox="1"/>
          <p:nvPr/>
        </p:nvSpPr>
        <p:spPr>
          <a:xfrm>
            <a:off x="127879" y="1551984"/>
            <a:ext cx="736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WOX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A6A9D91-E4E2-99AB-37DB-B99B6D83675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103" t="35155" r="23593" b="51308"/>
          <a:stretch/>
        </p:blipFill>
        <p:spPr>
          <a:xfrm>
            <a:off x="768581" y="542274"/>
            <a:ext cx="4681818" cy="6328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7F1B42E-B80E-1E65-29DA-A5E051E07729}"/>
              </a:ext>
            </a:extLst>
          </p:cNvPr>
          <p:cNvSpPr txBox="1"/>
          <p:nvPr/>
        </p:nvSpPr>
        <p:spPr>
          <a:xfrm>
            <a:off x="0" y="735205"/>
            <a:ext cx="870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dTomato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EB70C0A2-B21A-5A57-EDF2-1BBA10CBAEC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6274" t="45687" r="20101" b="37659"/>
          <a:stretch/>
        </p:blipFill>
        <p:spPr>
          <a:xfrm>
            <a:off x="768060" y="2752975"/>
            <a:ext cx="4682339" cy="7266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3061A068-0221-4A14-AD05-F32810DC0BFC}"/>
              </a:ext>
            </a:extLst>
          </p:cNvPr>
          <p:cNvSpPr txBox="1"/>
          <p:nvPr/>
        </p:nvSpPr>
        <p:spPr>
          <a:xfrm>
            <a:off x="350540" y="2841411"/>
            <a:ext cx="736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3483760-3A35-6461-2EAB-E8AA7538F46D}"/>
              </a:ext>
            </a:extLst>
          </p:cNvPr>
          <p:cNvSpPr txBox="1"/>
          <p:nvPr/>
        </p:nvSpPr>
        <p:spPr>
          <a:xfrm>
            <a:off x="177872" y="440836"/>
            <a:ext cx="808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7EB933E-344C-13B5-4DC0-AD36AF02C074}"/>
              </a:ext>
            </a:extLst>
          </p:cNvPr>
          <p:cNvSpPr txBox="1"/>
          <p:nvPr/>
        </p:nvSpPr>
        <p:spPr>
          <a:xfrm>
            <a:off x="177872" y="1400083"/>
            <a:ext cx="778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 kDa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DE29CA1-08EC-5EB9-75F3-2128965772D3}"/>
              </a:ext>
            </a:extLst>
          </p:cNvPr>
          <p:cNvSpPr txBox="1"/>
          <p:nvPr/>
        </p:nvSpPr>
        <p:spPr>
          <a:xfrm>
            <a:off x="165385" y="2017116"/>
            <a:ext cx="778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 kDa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066D172-328F-AD25-0110-83B33DA4A3CF}"/>
              </a:ext>
            </a:extLst>
          </p:cNvPr>
          <p:cNvSpPr txBox="1"/>
          <p:nvPr/>
        </p:nvSpPr>
        <p:spPr>
          <a:xfrm>
            <a:off x="150267" y="2993312"/>
            <a:ext cx="83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 kD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9F6C34E-577C-9446-AF77-2A44958DF007}"/>
              </a:ext>
            </a:extLst>
          </p:cNvPr>
          <p:cNvSpPr txBox="1"/>
          <p:nvPr/>
        </p:nvSpPr>
        <p:spPr>
          <a:xfrm>
            <a:off x="165385" y="3442207"/>
            <a:ext cx="736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55CE32D2-00E0-2817-7091-A4E606B075F4}"/>
              </a:ext>
            </a:extLst>
          </p:cNvPr>
          <p:cNvCxnSpPr>
            <a:cxnSpLocks/>
          </p:cNvCxnSpPr>
          <p:nvPr/>
        </p:nvCxnSpPr>
        <p:spPr>
          <a:xfrm flipH="1">
            <a:off x="4928124" y="3793175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21A2D5C9-EBF3-E700-3C75-A16B7BBF7F9F}"/>
              </a:ext>
            </a:extLst>
          </p:cNvPr>
          <p:cNvCxnSpPr>
            <a:cxnSpLocks/>
          </p:cNvCxnSpPr>
          <p:nvPr/>
        </p:nvCxnSpPr>
        <p:spPr>
          <a:xfrm flipH="1">
            <a:off x="5156785" y="3081739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53C49D8E-FC9C-17D9-4425-953C257997F0}"/>
              </a:ext>
            </a:extLst>
          </p:cNvPr>
          <p:cNvCxnSpPr>
            <a:cxnSpLocks/>
          </p:cNvCxnSpPr>
          <p:nvPr/>
        </p:nvCxnSpPr>
        <p:spPr>
          <a:xfrm flipH="1">
            <a:off x="5221738" y="2066370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5EC2D0F6-D109-9A3E-E6BF-71CCDC7A041B}"/>
              </a:ext>
            </a:extLst>
          </p:cNvPr>
          <p:cNvCxnSpPr>
            <a:cxnSpLocks/>
          </p:cNvCxnSpPr>
          <p:nvPr/>
        </p:nvCxnSpPr>
        <p:spPr>
          <a:xfrm flipH="1">
            <a:off x="4762664" y="1828983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641613CF-BFEF-D1F0-B468-C28452A832AF}"/>
              </a:ext>
            </a:extLst>
          </p:cNvPr>
          <p:cNvSpPr txBox="1"/>
          <p:nvPr/>
        </p:nvSpPr>
        <p:spPr>
          <a:xfrm>
            <a:off x="7616274" y="160988"/>
            <a:ext cx="1328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4S-C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DC3DCC7E-3DB3-1F23-380B-CBCCA201E981}"/>
              </a:ext>
            </a:extLst>
          </p:cNvPr>
          <p:cNvGrpSpPr/>
          <p:nvPr/>
        </p:nvGrpSpPr>
        <p:grpSpPr>
          <a:xfrm>
            <a:off x="6981805" y="490476"/>
            <a:ext cx="3999383" cy="4475433"/>
            <a:chOff x="6981805" y="490476"/>
            <a:chExt cx="3999383" cy="4475433"/>
          </a:xfrm>
        </p:grpSpPr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DD2FF89-47EF-0B14-9B1A-C18BCC5BF578}"/>
                </a:ext>
              </a:extLst>
            </p:cNvPr>
            <p:cNvSpPr txBox="1"/>
            <p:nvPr/>
          </p:nvSpPr>
          <p:spPr>
            <a:xfrm rot="18276989">
              <a:off x="9112370" y="4298899"/>
              <a:ext cx="3314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54B4B4D1-C745-94D3-9330-3C54AC681545}"/>
                </a:ext>
              </a:extLst>
            </p:cNvPr>
            <p:cNvCxnSpPr>
              <a:cxnSpLocks/>
            </p:cNvCxnSpPr>
            <p:nvPr/>
          </p:nvCxnSpPr>
          <p:spPr>
            <a:xfrm>
              <a:off x="9248706" y="4595228"/>
              <a:ext cx="3317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B97407CD-EEF7-076D-7866-9D8252D984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2559" t="53198" r="21420" b="19134"/>
            <a:stretch/>
          </p:blipFill>
          <p:spPr>
            <a:xfrm>
              <a:off x="7759505" y="3467744"/>
              <a:ext cx="2978403" cy="8984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550D6221-12F2-E961-A31D-079521C01F9D}"/>
                </a:ext>
              </a:extLst>
            </p:cNvPr>
            <p:cNvSpPr txBox="1"/>
            <p:nvPr/>
          </p:nvSpPr>
          <p:spPr>
            <a:xfrm>
              <a:off x="9116810" y="4627355"/>
              <a:ext cx="6703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KO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OM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BM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8AA17B2D-95BF-87A9-F333-F2F5A549B61F}"/>
                </a:ext>
              </a:extLst>
            </p:cNvPr>
            <p:cNvSpPr txBox="1"/>
            <p:nvPr/>
          </p:nvSpPr>
          <p:spPr>
            <a:xfrm>
              <a:off x="9638969" y="4603293"/>
              <a:ext cx="5978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KO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OM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BM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74B8D67B-D347-10D4-F840-844E8130304A}"/>
                </a:ext>
              </a:extLst>
            </p:cNvPr>
            <p:cNvSpPr txBox="1"/>
            <p:nvPr/>
          </p:nvSpPr>
          <p:spPr>
            <a:xfrm rot="19009217">
              <a:off x="10023233" y="4377475"/>
              <a:ext cx="6406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4B1300C6-B028-8CEE-FD4E-89E74BEE2254}"/>
                </a:ext>
              </a:extLst>
            </p:cNvPr>
            <p:cNvSpPr txBox="1"/>
            <p:nvPr/>
          </p:nvSpPr>
          <p:spPr>
            <a:xfrm>
              <a:off x="7029732" y="3525393"/>
              <a:ext cx="9143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60" name="Picture 159">
              <a:extLst>
                <a:ext uri="{FF2B5EF4-FFF2-40B4-BE49-F238E27FC236}">
                  <a16:creationId xmlns:a16="http://schemas.microsoft.com/office/drawing/2014/main" id="{03FF3F4D-DCF8-8AFF-8AC0-66C46223B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8598" t="60615" r="26210" b="19819"/>
            <a:stretch/>
          </p:blipFill>
          <p:spPr>
            <a:xfrm>
              <a:off x="7759505" y="2644613"/>
              <a:ext cx="2960434" cy="7827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FA1D7B94-9F17-5440-0624-E0666FCFD786}"/>
                </a:ext>
              </a:extLst>
            </p:cNvPr>
            <p:cNvSpPr txBox="1"/>
            <p:nvPr/>
          </p:nvSpPr>
          <p:spPr>
            <a:xfrm>
              <a:off x="7055027" y="3163631"/>
              <a:ext cx="9143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WOX</a:t>
              </a:r>
            </a:p>
          </p:txBody>
        </p:sp>
        <p:pic>
          <p:nvPicPr>
            <p:cNvPr id="162" name="Picture 161">
              <a:extLst>
                <a:ext uri="{FF2B5EF4-FFF2-40B4-BE49-F238E27FC236}">
                  <a16:creationId xmlns:a16="http://schemas.microsoft.com/office/drawing/2014/main" id="{4419D1A6-9009-E673-BEC2-A6A57157BD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1644" t="47361" r="21886" b="33420"/>
            <a:stretch/>
          </p:blipFill>
          <p:spPr>
            <a:xfrm>
              <a:off x="7759506" y="2025316"/>
              <a:ext cx="2960434" cy="5893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C9347546-CE72-3D9E-86AF-E6840A114F91}"/>
                </a:ext>
              </a:extLst>
            </p:cNvPr>
            <p:cNvSpPr txBox="1"/>
            <p:nvPr/>
          </p:nvSpPr>
          <p:spPr>
            <a:xfrm>
              <a:off x="7128295" y="2202593"/>
              <a:ext cx="9143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DD7D2777-7589-FF04-243D-6003392CABAB}"/>
                </a:ext>
              </a:extLst>
            </p:cNvPr>
            <p:cNvSpPr txBox="1"/>
            <p:nvPr/>
          </p:nvSpPr>
          <p:spPr>
            <a:xfrm>
              <a:off x="7055027" y="4361500"/>
              <a:ext cx="91439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R-10GR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(min)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20F7A5E-3DD6-AE5B-28B8-02178721FE2E}"/>
                </a:ext>
              </a:extLst>
            </p:cNvPr>
            <p:cNvSpPr txBox="1"/>
            <p:nvPr/>
          </p:nvSpPr>
          <p:spPr>
            <a:xfrm>
              <a:off x="6981805" y="637675"/>
              <a:ext cx="9143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</a:p>
          </p:txBody>
        </p:sp>
        <p:pic>
          <p:nvPicPr>
            <p:cNvPr id="166" name="Picture 165">
              <a:extLst>
                <a:ext uri="{FF2B5EF4-FFF2-40B4-BE49-F238E27FC236}">
                  <a16:creationId xmlns:a16="http://schemas.microsoft.com/office/drawing/2014/main" id="{0F1610E2-D373-E17F-6F58-ED2A8141D7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2828" t="31650" r="23883" b="32676"/>
            <a:stretch/>
          </p:blipFill>
          <p:spPr>
            <a:xfrm>
              <a:off x="7739606" y="634839"/>
              <a:ext cx="2998302" cy="13372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14B2E4B-7F69-EC48-183B-4571839DCC5F}"/>
                </a:ext>
              </a:extLst>
            </p:cNvPr>
            <p:cNvSpPr txBox="1"/>
            <p:nvPr/>
          </p:nvSpPr>
          <p:spPr>
            <a:xfrm>
              <a:off x="7088069" y="490476"/>
              <a:ext cx="808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7 kDa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1796590-68EF-D212-94F3-B24DA4C9621C}"/>
                </a:ext>
              </a:extLst>
            </p:cNvPr>
            <p:cNvSpPr txBox="1"/>
            <p:nvPr/>
          </p:nvSpPr>
          <p:spPr>
            <a:xfrm>
              <a:off x="7196049" y="2102960"/>
              <a:ext cx="7788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4F807714-5D99-2C64-85B4-A17D013D12DC}"/>
                </a:ext>
              </a:extLst>
            </p:cNvPr>
            <p:cNvSpPr txBox="1"/>
            <p:nvPr/>
          </p:nvSpPr>
          <p:spPr>
            <a:xfrm>
              <a:off x="7184953" y="2990654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3E4F4305-31A6-1118-E4C7-D6C0A7E41C37}"/>
                </a:ext>
              </a:extLst>
            </p:cNvPr>
            <p:cNvSpPr txBox="1"/>
            <p:nvPr/>
          </p:nvSpPr>
          <p:spPr>
            <a:xfrm>
              <a:off x="7164760" y="3369426"/>
              <a:ext cx="7368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7 kDa</a:t>
              </a:r>
            </a:p>
          </p:txBody>
        </p:sp>
        <p:cxnSp>
          <p:nvCxnSpPr>
            <p:cNvPr id="171" name="Straight Arrow Connector 170">
              <a:extLst>
                <a:ext uri="{FF2B5EF4-FFF2-40B4-BE49-F238E27FC236}">
                  <a16:creationId xmlns:a16="http://schemas.microsoft.com/office/drawing/2014/main" id="{BB757989-7B7B-7F21-3075-BDC1BBD265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540767" y="3646425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Arrow Connector 171">
              <a:extLst>
                <a:ext uri="{FF2B5EF4-FFF2-40B4-BE49-F238E27FC236}">
                  <a16:creationId xmlns:a16="http://schemas.microsoft.com/office/drawing/2014/main" id="{AE3995A2-B9B7-A535-1BCB-120B90D75B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687574" y="3267653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Arrow Connector 172">
              <a:extLst>
                <a:ext uri="{FF2B5EF4-FFF2-40B4-BE49-F238E27FC236}">
                  <a16:creationId xmlns:a16="http://schemas.microsoft.com/office/drawing/2014/main" id="{119BDDDA-0C75-42A7-79AE-603C150988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93435" y="2294115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Arrow Connector 173">
              <a:extLst>
                <a:ext uri="{FF2B5EF4-FFF2-40B4-BE49-F238E27FC236}">
                  <a16:creationId xmlns:a16="http://schemas.microsoft.com/office/drawing/2014/main" id="{49566EC2-EAD8-4521-055E-14EC2B1D16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357250" y="704822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BDDE69F5-14AC-9492-29EB-B2AF7FC34AB5}"/>
                </a:ext>
              </a:extLst>
            </p:cNvPr>
            <p:cNvSpPr txBox="1"/>
            <p:nvPr/>
          </p:nvSpPr>
          <p:spPr>
            <a:xfrm rot="18276989">
              <a:off x="9220927" y="4337916"/>
              <a:ext cx="3314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009C9B1-52E3-AC58-5109-0ACC24C3BB94}"/>
                </a:ext>
              </a:extLst>
            </p:cNvPr>
            <p:cNvSpPr txBox="1"/>
            <p:nvPr/>
          </p:nvSpPr>
          <p:spPr>
            <a:xfrm rot="18276989">
              <a:off x="9356371" y="4346561"/>
              <a:ext cx="3841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E9FAF5B8-2A68-52A4-8F18-067DE84696E2}"/>
                </a:ext>
              </a:extLst>
            </p:cNvPr>
            <p:cNvSpPr txBox="1"/>
            <p:nvPr/>
          </p:nvSpPr>
          <p:spPr>
            <a:xfrm rot="18276989">
              <a:off x="9603765" y="4298899"/>
              <a:ext cx="3314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EDCBF9C4-91E8-C8A8-067A-97E645FE95C6}"/>
                </a:ext>
              </a:extLst>
            </p:cNvPr>
            <p:cNvSpPr txBox="1"/>
            <p:nvPr/>
          </p:nvSpPr>
          <p:spPr>
            <a:xfrm rot="18276989">
              <a:off x="9729574" y="4337916"/>
              <a:ext cx="3314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7CAB8A9D-48E6-44CD-8CF3-1AA8C314982B}"/>
                </a:ext>
              </a:extLst>
            </p:cNvPr>
            <p:cNvSpPr txBox="1"/>
            <p:nvPr/>
          </p:nvSpPr>
          <p:spPr>
            <a:xfrm rot="18276989">
              <a:off x="9890896" y="4346561"/>
              <a:ext cx="3841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217EE7B0-E6EC-A8ED-2E6D-F4A419FA6FE0}"/>
                </a:ext>
              </a:extLst>
            </p:cNvPr>
            <p:cNvCxnSpPr>
              <a:cxnSpLocks/>
            </p:cNvCxnSpPr>
            <p:nvPr/>
          </p:nvCxnSpPr>
          <p:spPr>
            <a:xfrm>
              <a:off x="9729396" y="4595228"/>
              <a:ext cx="3317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1" name="TextBox 180">
            <a:extLst>
              <a:ext uri="{FF2B5EF4-FFF2-40B4-BE49-F238E27FC236}">
                <a16:creationId xmlns:a16="http://schemas.microsoft.com/office/drawing/2014/main" id="{6F123154-57EE-100E-E384-C6E93F14D032}"/>
              </a:ext>
            </a:extLst>
          </p:cNvPr>
          <p:cNvSpPr txBox="1"/>
          <p:nvPr/>
        </p:nvSpPr>
        <p:spPr>
          <a:xfrm>
            <a:off x="768060" y="119116"/>
            <a:ext cx="1328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1F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281AEDCE-6D8F-8496-0F7C-7EE4B86DD22D}"/>
              </a:ext>
            </a:extLst>
          </p:cNvPr>
          <p:cNvSpPr txBox="1"/>
          <p:nvPr/>
        </p:nvSpPr>
        <p:spPr>
          <a:xfrm>
            <a:off x="878966" y="4250877"/>
            <a:ext cx="1411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re+ WT BM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16B4883C-2548-EFF5-0274-23D36348D1AC}"/>
              </a:ext>
            </a:extLst>
          </p:cNvPr>
          <p:cNvSpPr txBox="1"/>
          <p:nvPr/>
        </p:nvSpPr>
        <p:spPr>
          <a:xfrm>
            <a:off x="1198048" y="4008629"/>
            <a:ext cx="2840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37231BC5-3C52-8CE6-DF66-055476B4066C}"/>
              </a:ext>
            </a:extLst>
          </p:cNvPr>
          <p:cNvSpPr txBox="1"/>
          <p:nvPr/>
        </p:nvSpPr>
        <p:spPr>
          <a:xfrm>
            <a:off x="1482133" y="4008629"/>
            <a:ext cx="3861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4B648380-82E8-278C-C1D4-6D1765138159}"/>
              </a:ext>
            </a:extLst>
          </p:cNvPr>
          <p:cNvSpPr txBox="1"/>
          <p:nvPr/>
        </p:nvSpPr>
        <p:spPr>
          <a:xfrm>
            <a:off x="1726272" y="4008629"/>
            <a:ext cx="461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C2C87A2D-D2CC-0589-EAE5-86425C6167D8}"/>
              </a:ext>
            </a:extLst>
          </p:cNvPr>
          <p:cNvSpPr txBox="1"/>
          <p:nvPr/>
        </p:nvSpPr>
        <p:spPr>
          <a:xfrm>
            <a:off x="2138782" y="4008629"/>
            <a:ext cx="2840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4E3579D-7628-27F2-E903-6A9CB2F3F039}"/>
              </a:ext>
            </a:extLst>
          </p:cNvPr>
          <p:cNvSpPr txBox="1"/>
          <p:nvPr/>
        </p:nvSpPr>
        <p:spPr>
          <a:xfrm>
            <a:off x="2366987" y="4008629"/>
            <a:ext cx="3861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5247252-B6A4-25EC-310F-DD3DA073C399}"/>
              </a:ext>
            </a:extLst>
          </p:cNvPr>
          <p:cNvSpPr txBox="1"/>
          <p:nvPr/>
        </p:nvSpPr>
        <p:spPr>
          <a:xfrm>
            <a:off x="2628104" y="4008629"/>
            <a:ext cx="461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CB163C4A-BB9F-B297-23E9-9A7A88ED60BC}"/>
              </a:ext>
            </a:extLst>
          </p:cNvPr>
          <p:cNvSpPr txBox="1"/>
          <p:nvPr/>
        </p:nvSpPr>
        <p:spPr>
          <a:xfrm>
            <a:off x="179560" y="4005194"/>
            <a:ext cx="8078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-10Gy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84DE24BE-BF44-1A22-35D5-5F6B838C3D8A}"/>
              </a:ext>
            </a:extLst>
          </p:cNvPr>
          <p:cNvSpPr txBox="1"/>
          <p:nvPr/>
        </p:nvSpPr>
        <p:spPr>
          <a:xfrm>
            <a:off x="136415" y="4194067"/>
            <a:ext cx="1036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6BE28D94-996F-FFD3-40ED-20226F266EDB}"/>
              </a:ext>
            </a:extLst>
          </p:cNvPr>
          <p:cNvSpPr txBox="1"/>
          <p:nvPr/>
        </p:nvSpPr>
        <p:spPr>
          <a:xfrm>
            <a:off x="1805912" y="4250877"/>
            <a:ext cx="1411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KO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TO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BM</a:t>
            </a:r>
          </a:p>
        </p:txBody>
      </p: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0BA76015-A2CA-B713-B4A8-7B19B9ECCA96}"/>
              </a:ext>
            </a:extLst>
          </p:cNvPr>
          <p:cNvCxnSpPr>
            <a:cxnSpLocks/>
          </p:cNvCxnSpPr>
          <p:nvPr/>
        </p:nvCxnSpPr>
        <p:spPr>
          <a:xfrm>
            <a:off x="1262417" y="4248062"/>
            <a:ext cx="7834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F18C3C1B-F0E9-FD12-298E-2367B6114C60}"/>
              </a:ext>
            </a:extLst>
          </p:cNvPr>
          <p:cNvCxnSpPr>
            <a:cxnSpLocks/>
          </p:cNvCxnSpPr>
          <p:nvPr/>
        </p:nvCxnSpPr>
        <p:spPr>
          <a:xfrm>
            <a:off x="2187911" y="4256451"/>
            <a:ext cx="7834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Arrow Connector 228">
            <a:extLst>
              <a:ext uri="{FF2B5EF4-FFF2-40B4-BE49-F238E27FC236}">
                <a16:creationId xmlns:a16="http://schemas.microsoft.com/office/drawing/2014/main" id="{02F2AC07-2157-9112-DD1D-C6BC1BC5E22E}"/>
              </a:ext>
            </a:extLst>
          </p:cNvPr>
          <p:cNvCxnSpPr>
            <a:cxnSpLocks/>
          </p:cNvCxnSpPr>
          <p:nvPr/>
        </p:nvCxnSpPr>
        <p:spPr>
          <a:xfrm flipH="1">
            <a:off x="4863171" y="704822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0106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Box 97">
            <a:extLst>
              <a:ext uri="{FF2B5EF4-FFF2-40B4-BE49-F238E27FC236}">
                <a16:creationId xmlns:a16="http://schemas.microsoft.com/office/drawing/2014/main" id="{F360A670-0197-B4D7-7CE5-53C958A3673A}"/>
              </a:ext>
            </a:extLst>
          </p:cNvPr>
          <p:cNvSpPr txBox="1"/>
          <p:nvPr/>
        </p:nvSpPr>
        <p:spPr>
          <a:xfrm>
            <a:off x="90876" y="2559331"/>
            <a:ext cx="8700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E40CBAF2-E745-000F-23EF-A64F7258ADAA}"/>
              </a:ext>
            </a:extLst>
          </p:cNvPr>
          <p:cNvGrpSpPr/>
          <p:nvPr/>
        </p:nvGrpSpPr>
        <p:grpSpPr>
          <a:xfrm>
            <a:off x="103130" y="654568"/>
            <a:ext cx="5549238" cy="3435009"/>
            <a:chOff x="5641676" y="887482"/>
            <a:chExt cx="5549238" cy="3435009"/>
          </a:xfrm>
        </p:grpSpPr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930B69A0-466F-9876-1B16-E78BD548E2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143" t="59551" r="23323" b="7574"/>
            <a:stretch/>
          </p:blipFill>
          <p:spPr>
            <a:xfrm>
              <a:off x="6316910" y="2716162"/>
              <a:ext cx="4874004" cy="8881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AD225BE5-B2DF-DEB6-0709-A383611F72B2}"/>
                </a:ext>
              </a:extLst>
            </p:cNvPr>
            <p:cNvSpPr txBox="1"/>
            <p:nvPr/>
          </p:nvSpPr>
          <p:spPr>
            <a:xfrm rot="19422101">
              <a:off x="6807052" y="3622017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BM-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984E457A-BF37-0827-2753-623EB6FA62B4}"/>
                </a:ext>
              </a:extLst>
            </p:cNvPr>
            <p:cNvSpPr txBox="1"/>
            <p:nvPr/>
          </p:nvSpPr>
          <p:spPr>
            <a:xfrm rot="19013590">
              <a:off x="7125048" y="3652512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BM-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0A20F846-ED49-6035-050C-F316A378B890}"/>
                </a:ext>
              </a:extLst>
            </p:cNvPr>
            <p:cNvSpPr txBox="1"/>
            <p:nvPr/>
          </p:nvSpPr>
          <p:spPr>
            <a:xfrm rot="19177284">
              <a:off x="7443044" y="3634777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BM-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0D2A697-FD77-75BC-54D4-BFFE33D8422D}"/>
                </a:ext>
              </a:extLst>
            </p:cNvPr>
            <p:cNvSpPr txBox="1"/>
            <p:nvPr/>
          </p:nvSpPr>
          <p:spPr>
            <a:xfrm rot="19066099">
              <a:off x="7686764" y="3686937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BM-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D5564A7-60A3-CE92-BF4D-4170B412A9C9}"/>
                </a:ext>
              </a:extLst>
            </p:cNvPr>
            <p:cNvSpPr txBox="1"/>
            <p:nvPr/>
          </p:nvSpPr>
          <p:spPr>
            <a:xfrm rot="18873364">
              <a:off x="7994258" y="3670922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BM-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5D168AB5-C09D-1929-E4C6-3AD25C1C3BAB}"/>
                </a:ext>
              </a:extLst>
            </p:cNvPr>
            <p:cNvCxnSpPr>
              <a:cxnSpLocks/>
            </p:cNvCxnSpPr>
            <p:nvPr/>
          </p:nvCxnSpPr>
          <p:spPr>
            <a:xfrm>
              <a:off x="6883298" y="4060218"/>
              <a:ext cx="6199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7833FD8D-A333-BDBA-D166-7563F5D16F14}"/>
                </a:ext>
              </a:extLst>
            </p:cNvPr>
            <p:cNvCxnSpPr>
              <a:cxnSpLocks/>
            </p:cNvCxnSpPr>
            <p:nvPr/>
          </p:nvCxnSpPr>
          <p:spPr>
            <a:xfrm>
              <a:off x="7609902" y="4059191"/>
              <a:ext cx="930091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34A3BB6D-F469-039B-CB0B-B98F9FED9E2D}"/>
                </a:ext>
              </a:extLst>
            </p:cNvPr>
            <p:cNvSpPr txBox="1"/>
            <p:nvPr/>
          </p:nvSpPr>
          <p:spPr>
            <a:xfrm>
              <a:off x="6734883" y="4076270"/>
              <a:ext cx="9522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KO-yBM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90A6A41F-6D4F-5E27-6509-8D41FF959E8A}"/>
                </a:ext>
              </a:extLst>
            </p:cNvPr>
            <p:cNvSpPr txBox="1"/>
            <p:nvPr/>
          </p:nvSpPr>
          <p:spPr>
            <a:xfrm>
              <a:off x="7674777" y="4075243"/>
              <a:ext cx="9522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KO-yBM</a:t>
              </a:r>
            </a:p>
          </p:txBody>
        </p:sp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BDF367D0-8C6F-EAE8-92D3-76F3F139E8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1631" t="39235" r="22032" b="27410"/>
            <a:stretch/>
          </p:blipFill>
          <p:spPr>
            <a:xfrm>
              <a:off x="6320197" y="1534433"/>
              <a:ext cx="4852052" cy="11239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E4C22A5E-2014-A162-8CDC-0134009A67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2462" t="29463" r="21774" b="37908"/>
            <a:stretch/>
          </p:blipFill>
          <p:spPr>
            <a:xfrm>
              <a:off x="6316910" y="887482"/>
              <a:ext cx="4852052" cy="5765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9F4C44AD-CDB8-F300-B812-FC9C85B29A56}"/>
                </a:ext>
              </a:extLst>
            </p:cNvPr>
            <p:cNvSpPr txBox="1"/>
            <p:nvPr/>
          </p:nvSpPr>
          <p:spPr>
            <a:xfrm>
              <a:off x="5641676" y="1498005"/>
              <a:ext cx="870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7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029FC97A-0782-49B3-E117-47985BFF5E87}"/>
                </a:ext>
              </a:extLst>
            </p:cNvPr>
            <p:cNvSpPr txBox="1"/>
            <p:nvPr/>
          </p:nvSpPr>
          <p:spPr>
            <a:xfrm>
              <a:off x="5655386" y="977959"/>
              <a:ext cx="870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5224610-4F6E-89E3-7F92-A5B28C7EEFA8}"/>
                </a:ext>
              </a:extLst>
            </p:cNvPr>
            <p:cNvSpPr txBox="1"/>
            <p:nvPr/>
          </p:nvSpPr>
          <p:spPr>
            <a:xfrm>
              <a:off x="5700947" y="1107471"/>
              <a:ext cx="7788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B7ECF448-45BF-ADB7-7B23-B4459B7E2435}"/>
                </a:ext>
              </a:extLst>
            </p:cNvPr>
            <p:cNvSpPr txBox="1"/>
            <p:nvPr/>
          </p:nvSpPr>
          <p:spPr>
            <a:xfrm>
              <a:off x="5700947" y="1621115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 kDa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7BCBE6A-A8C4-64B0-874B-72971AF04CFD}"/>
                </a:ext>
              </a:extLst>
            </p:cNvPr>
            <p:cNvSpPr txBox="1"/>
            <p:nvPr/>
          </p:nvSpPr>
          <p:spPr>
            <a:xfrm>
              <a:off x="5718101" y="2615704"/>
              <a:ext cx="7368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7 kDa</a:t>
              </a:r>
            </a:p>
          </p:txBody>
        </p:sp>
        <p:cxnSp>
          <p:nvCxnSpPr>
            <p:cNvPr id="130" name="Straight Arrow Connector 129">
              <a:extLst>
                <a:ext uri="{FF2B5EF4-FFF2-40B4-BE49-F238E27FC236}">
                  <a16:creationId xmlns:a16="http://schemas.microsoft.com/office/drawing/2014/main" id="{1F8C981F-AF2C-81A1-E035-EA64F6D0AB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27525" y="2804004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Arrow Connector 130">
              <a:extLst>
                <a:ext uri="{FF2B5EF4-FFF2-40B4-BE49-F238E27FC236}">
                  <a16:creationId xmlns:a16="http://schemas.microsoft.com/office/drawing/2014/main" id="{454ECB9A-E8EC-C342-0875-84FCE80CCC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27525" y="1663431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9039C0B8-476B-5E37-FFCD-70705683D74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471171" y="1175741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7C7877A7-CC18-F965-5FC9-68679752D1EB}"/>
              </a:ext>
            </a:extLst>
          </p:cNvPr>
          <p:cNvCxnSpPr>
            <a:cxnSpLocks/>
          </p:cNvCxnSpPr>
          <p:nvPr/>
        </p:nvCxnSpPr>
        <p:spPr>
          <a:xfrm flipH="1">
            <a:off x="11226362" y="685"/>
            <a:ext cx="2936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93297CFF-9347-BF4B-5CCD-527442258992}"/>
              </a:ext>
            </a:extLst>
          </p:cNvPr>
          <p:cNvSpPr txBox="1"/>
          <p:nvPr/>
        </p:nvSpPr>
        <p:spPr>
          <a:xfrm>
            <a:off x="896524" y="220696"/>
            <a:ext cx="1328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5S-F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E449CBCC-BA71-499A-3432-9BC9EEF5269A}"/>
              </a:ext>
            </a:extLst>
          </p:cNvPr>
          <p:cNvGrpSpPr/>
          <p:nvPr/>
        </p:nvGrpSpPr>
        <p:grpSpPr>
          <a:xfrm>
            <a:off x="7003000" y="556020"/>
            <a:ext cx="4637154" cy="2815400"/>
            <a:chOff x="6189136" y="874897"/>
            <a:chExt cx="4637154" cy="2815400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011F716A-028D-E093-CB89-5192B315A463}"/>
                </a:ext>
              </a:extLst>
            </p:cNvPr>
            <p:cNvSpPr txBox="1"/>
            <p:nvPr/>
          </p:nvSpPr>
          <p:spPr>
            <a:xfrm>
              <a:off x="6189136" y="874897"/>
              <a:ext cx="7260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7</a:t>
              </a:r>
            </a:p>
          </p:txBody>
        </p:sp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D0B312AB-1E4A-4831-AB37-AF6A06975C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746" t="58104" r="27584" b="7486"/>
            <a:stretch/>
          </p:blipFill>
          <p:spPr>
            <a:xfrm>
              <a:off x="6857524" y="2180607"/>
              <a:ext cx="3968766" cy="11076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9A535037-B060-3230-B224-B0B7269C52E1}"/>
                </a:ext>
              </a:extLst>
            </p:cNvPr>
            <p:cNvSpPr txBox="1"/>
            <p:nvPr/>
          </p:nvSpPr>
          <p:spPr>
            <a:xfrm>
              <a:off x="6189136" y="3019734"/>
              <a:ext cx="7260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pic>
          <p:nvPicPr>
            <p:cNvPr id="140" name="Picture 139">
              <a:extLst>
                <a:ext uri="{FF2B5EF4-FFF2-40B4-BE49-F238E27FC236}">
                  <a16:creationId xmlns:a16="http://schemas.microsoft.com/office/drawing/2014/main" id="{D246336D-B759-96A7-034B-7552A1A60E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1602" t="37424" r="27971" b="30438"/>
            <a:stretch/>
          </p:blipFill>
          <p:spPr>
            <a:xfrm>
              <a:off x="6857524" y="888143"/>
              <a:ext cx="3968766" cy="12697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D269A557-68E6-6594-CD34-5F320CCDCA85}"/>
                </a:ext>
              </a:extLst>
            </p:cNvPr>
            <p:cNvGrpSpPr/>
            <p:nvPr/>
          </p:nvGrpSpPr>
          <p:grpSpPr>
            <a:xfrm>
              <a:off x="6573161" y="3131945"/>
              <a:ext cx="2449412" cy="558352"/>
              <a:chOff x="1016417" y="4893017"/>
              <a:chExt cx="2525907" cy="467468"/>
            </a:xfrm>
          </p:grpSpPr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F3028C20-E43F-6AD9-C353-CD0243C05C70}"/>
                  </a:ext>
                </a:extLst>
              </p:cNvPr>
              <p:cNvSpPr txBox="1"/>
              <p:nvPr/>
            </p:nvSpPr>
            <p:spPr>
              <a:xfrm rot="19427973">
                <a:off x="1016417" y="5073979"/>
                <a:ext cx="1142567" cy="206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+ WT BM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C38D374B-4C69-737F-042D-B3D0E7A2E4FC}"/>
                  </a:ext>
                </a:extLst>
              </p:cNvPr>
              <p:cNvSpPr txBox="1"/>
              <p:nvPr/>
            </p:nvSpPr>
            <p:spPr>
              <a:xfrm rot="19172151">
                <a:off x="1720376" y="5032079"/>
                <a:ext cx="575788" cy="206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BM-1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700D6B82-D58B-4BE4-7FD6-6BA121766551}"/>
                  </a:ext>
                </a:extLst>
              </p:cNvPr>
              <p:cNvSpPr txBox="1"/>
              <p:nvPr/>
            </p:nvSpPr>
            <p:spPr>
              <a:xfrm rot="19227779">
                <a:off x="1971195" y="5064423"/>
                <a:ext cx="575789" cy="206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BM-2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D19CA0DC-454D-50EC-BF4C-54D94F114C0E}"/>
                  </a:ext>
                </a:extLst>
              </p:cNvPr>
              <p:cNvSpPr txBox="1"/>
              <p:nvPr/>
            </p:nvSpPr>
            <p:spPr>
              <a:xfrm rot="19090297">
                <a:off x="2339943" y="5073978"/>
                <a:ext cx="1010567" cy="206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MT-2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309E2C2D-27CD-9186-41A1-A8417F7854E1}"/>
                  </a:ext>
                </a:extLst>
              </p:cNvPr>
              <p:cNvSpPr txBox="1"/>
              <p:nvPr/>
            </p:nvSpPr>
            <p:spPr>
              <a:xfrm rot="19067620">
                <a:off x="2139739" y="4920798"/>
                <a:ext cx="1296541" cy="2061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MT-1	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C0F2A092-5AAB-1D55-100E-4A1A13E9F31F}"/>
                  </a:ext>
                </a:extLst>
              </p:cNvPr>
              <p:cNvSpPr txBox="1"/>
              <p:nvPr/>
            </p:nvSpPr>
            <p:spPr>
              <a:xfrm rot="19001655">
                <a:off x="2888048" y="5011045"/>
                <a:ext cx="575789" cy="2061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-1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C9BD01C8-E797-7999-961E-ABE43E974FBC}"/>
                  </a:ext>
                </a:extLst>
              </p:cNvPr>
              <p:cNvSpPr txBox="1"/>
              <p:nvPr/>
            </p:nvSpPr>
            <p:spPr>
              <a:xfrm rot="18823611">
                <a:off x="3181635" y="4999795"/>
                <a:ext cx="467468" cy="2539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-2</a:t>
                </a:r>
              </a:p>
            </p:txBody>
          </p:sp>
        </p:grp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93A1585-2596-FB57-DF6E-4D033BABDE63}"/>
                </a:ext>
              </a:extLst>
            </p:cNvPr>
            <p:cNvSpPr txBox="1"/>
            <p:nvPr/>
          </p:nvSpPr>
          <p:spPr>
            <a:xfrm>
              <a:off x="6258574" y="2710145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535F9A87-28D7-8C48-DD2D-DD1072FB59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714531" y="3140124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7EAE0C90-CD3E-E4F4-FBD5-83D2721A9EAD}"/>
                </a:ext>
              </a:extLst>
            </p:cNvPr>
            <p:cNvSpPr txBox="1"/>
            <p:nvPr/>
          </p:nvSpPr>
          <p:spPr>
            <a:xfrm>
              <a:off x="6258574" y="995936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 kDa</a:t>
              </a:r>
            </a:p>
          </p:txBody>
        </p:sp>
        <p:cxnSp>
          <p:nvCxnSpPr>
            <p:cNvPr id="145" name="Straight Arrow Connector 144">
              <a:extLst>
                <a:ext uri="{FF2B5EF4-FFF2-40B4-BE49-F238E27FC236}">
                  <a16:creationId xmlns:a16="http://schemas.microsoft.com/office/drawing/2014/main" id="{960A1486-E121-B23D-5C93-4DF885FDCC3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714531" y="1087562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B04D37AB-25DD-DCF0-C687-B1F9263D3C7C}"/>
              </a:ext>
            </a:extLst>
          </p:cNvPr>
          <p:cNvSpPr txBox="1"/>
          <p:nvPr/>
        </p:nvSpPr>
        <p:spPr>
          <a:xfrm>
            <a:off x="8336459" y="3886134"/>
            <a:ext cx="2935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7B-lower panel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16BEA7CE-88F2-441B-14F9-6D9E18956CE0}"/>
              </a:ext>
            </a:extLst>
          </p:cNvPr>
          <p:cNvGrpSpPr/>
          <p:nvPr/>
        </p:nvGrpSpPr>
        <p:grpSpPr>
          <a:xfrm>
            <a:off x="7602553" y="4223962"/>
            <a:ext cx="4101542" cy="2633353"/>
            <a:chOff x="6082693" y="2140472"/>
            <a:chExt cx="4101542" cy="2633353"/>
          </a:xfrm>
        </p:grpSpPr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810D659-F152-FD7D-CD56-7256C0ED3B52}"/>
                </a:ext>
              </a:extLst>
            </p:cNvPr>
            <p:cNvSpPr txBox="1"/>
            <p:nvPr/>
          </p:nvSpPr>
          <p:spPr>
            <a:xfrm>
              <a:off x="6182154" y="3972014"/>
              <a:ext cx="7368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4ACF895B-ECC2-4ABD-ACEA-27DDB29A2A10}"/>
                </a:ext>
              </a:extLst>
            </p:cNvPr>
            <p:cNvSpPr txBox="1"/>
            <p:nvPr/>
          </p:nvSpPr>
          <p:spPr>
            <a:xfrm>
              <a:off x="6144925" y="2524289"/>
              <a:ext cx="7368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7</a:t>
              </a:r>
            </a:p>
          </p:txBody>
        </p:sp>
        <p:pic>
          <p:nvPicPr>
            <p:cNvPr id="157" name="Picture 156">
              <a:extLst>
                <a:ext uri="{FF2B5EF4-FFF2-40B4-BE49-F238E27FC236}">
                  <a16:creationId xmlns:a16="http://schemas.microsoft.com/office/drawing/2014/main" id="{56D8C16B-92E7-D076-084F-4641B659D8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1676" t="25389" r="23307" b="41745"/>
            <a:stretch/>
          </p:blipFill>
          <p:spPr>
            <a:xfrm>
              <a:off x="6677637" y="2648932"/>
              <a:ext cx="3212984" cy="6789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ACE62815-EA4B-4737-A4D8-27DEE19C4A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3657" t="34874" r="21307" b="31647"/>
            <a:stretch/>
          </p:blipFill>
          <p:spPr>
            <a:xfrm>
              <a:off x="6694029" y="2143616"/>
              <a:ext cx="3195582" cy="4325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D4A4265C-F3BD-13B7-E0D3-58F3B3B30A16}"/>
                </a:ext>
              </a:extLst>
            </p:cNvPr>
            <p:cNvSpPr txBox="1"/>
            <p:nvPr/>
          </p:nvSpPr>
          <p:spPr>
            <a:xfrm>
              <a:off x="6184782" y="2140472"/>
              <a:ext cx="7368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-Myc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A72471E4-3FF8-E1F4-4F09-4C9BEA063734}"/>
                </a:ext>
              </a:extLst>
            </p:cNvPr>
            <p:cNvSpPr txBox="1"/>
            <p:nvPr/>
          </p:nvSpPr>
          <p:spPr>
            <a:xfrm>
              <a:off x="6772279" y="4435271"/>
              <a:ext cx="6739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re+W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M</a:t>
              </a:r>
            </a:p>
          </p:txBody>
        </p:sp>
        <p:pic>
          <p:nvPicPr>
            <p:cNvPr id="161" name="Picture 160">
              <a:extLst>
                <a:ext uri="{FF2B5EF4-FFF2-40B4-BE49-F238E27FC236}">
                  <a16:creationId xmlns:a16="http://schemas.microsoft.com/office/drawing/2014/main" id="{0530A1D4-B331-46FB-57C5-7A480CEABE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1238" t="52955" r="24415" b="14380"/>
            <a:stretch/>
          </p:blipFill>
          <p:spPr>
            <a:xfrm>
              <a:off x="6677637" y="3384273"/>
              <a:ext cx="3212984" cy="8662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7037D449-3A96-75C5-80FB-C31658680806}"/>
                </a:ext>
              </a:extLst>
            </p:cNvPr>
            <p:cNvGrpSpPr/>
            <p:nvPr/>
          </p:nvGrpSpPr>
          <p:grpSpPr>
            <a:xfrm>
              <a:off x="6987115" y="4235074"/>
              <a:ext cx="2549352" cy="437652"/>
              <a:chOff x="1461789" y="5210397"/>
              <a:chExt cx="3453283" cy="615274"/>
            </a:xfrm>
          </p:grpSpPr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6FF3A7FA-287A-0FF5-60FF-663376E067B7}"/>
                  </a:ext>
                </a:extLst>
              </p:cNvPr>
              <p:cNvSpPr txBox="1"/>
              <p:nvPr/>
            </p:nvSpPr>
            <p:spPr>
              <a:xfrm>
                <a:off x="1461789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E7648C0D-DC05-675E-4445-2B0DDC275AF7}"/>
                  </a:ext>
                </a:extLst>
              </p:cNvPr>
              <p:cNvSpPr txBox="1"/>
              <p:nvPr/>
            </p:nvSpPr>
            <p:spPr>
              <a:xfrm>
                <a:off x="1675079" y="5212629"/>
                <a:ext cx="507178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D0A13C41-8CA9-B468-5003-8F223C5F6FC5}"/>
                  </a:ext>
                </a:extLst>
              </p:cNvPr>
              <p:cNvSpPr txBox="1"/>
              <p:nvPr/>
            </p:nvSpPr>
            <p:spPr>
              <a:xfrm>
                <a:off x="2056822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115070C1-D1FB-BD98-B9F7-0ED2EB9C7E83}"/>
                  </a:ext>
                </a:extLst>
              </p:cNvPr>
              <p:cNvSpPr txBox="1"/>
              <p:nvPr/>
            </p:nvSpPr>
            <p:spPr>
              <a:xfrm>
                <a:off x="2250457" y="5212628"/>
                <a:ext cx="442612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9D793F9A-9491-601F-769D-3EE5E8D3B746}"/>
                  </a:ext>
                </a:extLst>
              </p:cNvPr>
              <p:cNvSpPr txBox="1"/>
              <p:nvPr/>
            </p:nvSpPr>
            <p:spPr>
              <a:xfrm>
                <a:off x="3695550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3784908F-504F-EF7E-319B-FCD40722F480}"/>
                  </a:ext>
                </a:extLst>
              </p:cNvPr>
              <p:cNvSpPr txBox="1"/>
              <p:nvPr/>
            </p:nvSpPr>
            <p:spPr>
              <a:xfrm>
                <a:off x="3878357" y="5212629"/>
                <a:ext cx="440964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4EAC3FB2-2C1C-9A7D-2898-94527FACF750}"/>
                  </a:ext>
                </a:extLst>
              </p:cNvPr>
              <p:cNvSpPr txBox="1"/>
              <p:nvPr/>
            </p:nvSpPr>
            <p:spPr>
              <a:xfrm>
                <a:off x="2558447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6916B608-A567-988B-FD28-84D7EEEC2E2C}"/>
                  </a:ext>
                </a:extLst>
              </p:cNvPr>
              <p:cNvSpPr txBox="1"/>
              <p:nvPr/>
            </p:nvSpPr>
            <p:spPr>
              <a:xfrm>
                <a:off x="2805775" y="5212628"/>
                <a:ext cx="423937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9AD8918B-6659-3763-F4D0-1073CE66365A}"/>
                  </a:ext>
                </a:extLst>
              </p:cNvPr>
              <p:cNvSpPr txBox="1"/>
              <p:nvPr/>
            </p:nvSpPr>
            <p:spPr>
              <a:xfrm>
                <a:off x="3122997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85351690-FCDA-C00E-BD1B-55A7633BD94F}"/>
                  </a:ext>
                </a:extLst>
              </p:cNvPr>
              <p:cNvSpPr txBox="1"/>
              <p:nvPr/>
            </p:nvSpPr>
            <p:spPr>
              <a:xfrm>
                <a:off x="3353420" y="5210397"/>
                <a:ext cx="442612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995336C0-CF06-457B-FCBC-8BFEF1E7ACED}"/>
                  </a:ext>
                </a:extLst>
              </p:cNvPr>
              <p:cNvSpPr txBox="1"/>
              <p:nvPr/>
            </p:nvSpPr>
            <p:spPr>
              <a:xfrm>
                <a:off x="1933495" y="5487536"/>
                <a:ext cx="697347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BM 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49A79821-1AF9-7DA4-23B5-3E67AEE41A41}"/>
                  </a:ext>
                </a:extLst>
              </p:cNvPr>
              <p:cNvSpPr txBox="1"/>
              <p:nvPr/>
            </p:nvSpPr>
            <p:spPr>
              <a:xfrm>
                <a:off x="3679924" y="5487536"/>
                <a:ext cx="513440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-1</a:t>
                </a:r>
              </a:p>
            </p:txBody>
          </p:sp>
          <p:cxnSp>
            <p:nvCxnSpPr>
              <p:cNvPr id="181" name="Straight Connector 180">
                <a:extLst>
                  <a:ext uri="{FF2B5EF4-FFF2-40B4-BE49-F238E27FC236}">
                    <a16:creationId xmlns:a16="http://schemas.microsoft.com/office/drawing/2014/main" id="{863DE8D7-BDC4-98EC-F253-47C334C5B4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38513" y="5497080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125BBE15-27DF-03B4-1D14-0BA7CDB91702}"/>
                  </a:ext>
                </a:extLst>
              </p:cNvPr>
              <p:cNvSpPr txBox="1"/>
              <p:nvPr/>
            </p:nvSpPr>
            <p:spPr>
              <a:xfrm>
                <a:off x="2402315" y="5487536"/>
                <a:ext cx="754321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MT-1 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66A1DDA9-E575-C66F-C493-51F42B6F8551}"/>
                  </a:ext>
                </a:extLst>
              </p:cNvPr>
              <p:cNvSpPr txBox="1"/>
              <p:nvPr/>
            </p:nvSpPr>
            <p:spPr>
              <a:xfrm>
                <a:off x="3031578" y="5487534"/>
                <a:ext cx="686636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MT-2</a:t>
                </a: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21AF6699-87AF-4F2D-8570-EA3818632101}"/>
                  </a:ext>
                </a:extLst>
              </p:cNvPr>
              <p:cNvSpPr txBox="1"/>
              <p:nvPr/>
            </p:nvSpPr>
            <p:spPr>
              <a:xfrm>
                <a:off x="4284748" y="5487536"/>
                <a:ext cx="562799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-2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3493FED7-8A91-D43A-2D6C-066F2E34B82E}"/>
                  </a:ext>
                </a:extLst>
              </p:cNvPr>
              <p:cNvSpPr txBox="1"/>
              <p:nvPr/>
            </p:nvSpPr>
            <p:spPr>
              <a:xfrm>
                <a:off x="4247990" y="5212630"/>
                <a:ext cx="381744" cy="33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BF615FBA-B0BD-23F7-913B-17B746275013}"/>
                  </a:ext>
                </a:extLst>
              </p:cNvPr>
              <p:cNvSpPr txBox="1"/>
              <p:nvPr/>
            </p:nvSpPr>
            <p:spPr>
              <a:xfrm>
                <a:off x="4474110" y="5212629"/>
                <a:ext cx="440962" cy="302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A6B9CC5C-532E-A3CE-A75D-5DE18D5DCC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2590" y="5511012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5D225FFE-6891-CDB9-DD95-79C55212A3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59135" y="5506622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2F12F65A-BAF0-EB1C-FFB2-8649A11FA3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23763" y="5487536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189">
                <a:extLst>
                  <a:ext uri="{FF2B5EF4-FFF2-40B4-BE49-F238E27FC236}">
                    <a16:creationId xmlns:a16="http://schemas.microsoft.com/office/drawing/2014/main" id="{B2201043-C798-F143-1A5A-CF2B2F1E61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76411" y="5506622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id="{7007A9F5-69D9-F024-75AA-BEA5E132FA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8724" y="5511012"/>
                <a:ext cx="36602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3" name="Straight Arrow Connector 162">
              <a:extLst>
                <a:ext uri="{FF2B5EF4-FFF2-40B4-BE49-F238E27FC236}">
                  <a16:creationId xmlns:a16="http://schemas.microsoft.com/office/drawing/2014/main" id="{311C8A97-52BD-57A3-C500-5689A97075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890621" y="4155096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5F4EFE49-BB84-B9D5-D310-A82370DCFEB7}"/>
                </a:ext>
              </a:extLst>
            </p:cNvPr>
            <p:cNvSpPr txBox="1"/>
            <p:nvPr/>
          </p:nvSpPr>
          <p:spPr>
            <a:xfrm>
              <a:off x="6082693" y="3771262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cxnSp>
          <p:nvCxnSpPr>
            <p:cNvPr id="165" name="Straight Arrow Connector 164">
              <a:extLst>
                <a:ext uri="{FF2B5EF4-FFF2-40B4-BE49-F238E27FC236}">
                  <a16:creationId xmlns:a16="http://schemas.microsoft.com/office/drawing/2014/main" id="{35556BD3-4381-51AB-BBEE-27B1186385D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890621" y="2772900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A1D7A968-B32A-7C52-E072-E002D47309C1}"/>
                </a:ext>
              </a:extLst>
            </p:cNvPr>
            <p:cNvSpPr txBox="1"/>
            <p:nvPr/>
          </p:nvSpPr>
          <p:spPr>
            <a:xfrm>
              <a:off x="6096000" y="2638143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 kDa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C898459F-D527-063B-22A5-61E31F2330E1}"/>
                </a:ext>
              </a:extLst>
            </p:cNvPr>
            <p:cNvSpPr txBox="1"/>
            <p:nvPr/>
          </p:nvSpPr>
          <p:spPr>
            <a:xfrm>
              <a:off x="6095194" y="2253053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cxnSp>
          <p:nvCxnSpPr>
            <p:cNvPr id="168" name="Straight Arrow Connector 167">
              <a:extLst>
                <a:ext uri="{FF2B5EF4-FFF2-40B4-BE49-F238E27FC236}">
                  <a16:creationId xmlns:a16="http://schemas.microsoft.com/office/drawing/2014/main" id="{BBA8B28D-53E3-FEFC-A7D9-D3AD287ED8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889611" y="2369005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2" name="TextBox 191">
            <a:extLst>
              <a:ext uri="{FF2B5EF4-FFF2-40B4-BE49-F238E27FC236}">
                <a16:creationId xmlns:a16="http://schemas.microsoft.com/office/drawing/2014/main" id="{161FA69C-2A4F-927C-1F48-7F620D6F62A3}"/>
              </a:ext>
            </a:extLst>
          </p:cNvPr>
          <p:cNvSpPr txBox="1"/>
          <p:nvPr/>
        </p:nvSpPr>
        <p:spPr>
          <a:xfrm>
            <a:off x="7758305" y="130574"/>
            <a:ext cx="2935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7B-upper panel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7677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1" name="Group 250">
            <a:extLst>
              <a:ext uri="{FF2B5EF4-FFF2-40B4-BE49-F238E27FC236}">
                <a16:creationId xmlns:a16="http://schemas.microsoft.com/office/drawing/2014/main" id="{D7819FCD-5756-228F-D082-7B6A3D0776D7}"/>
              </a:ext>
            </a:extLst>
          </p:cNvPr>
          <p:cNvGrpSpPr/>
          <p:nvPr/>
        </p:nvGrpSpPr>
        <p:grpSpPr>
          <a:xfrm>
            <a:off x="373565" y="880334"/>
            <a:ext cx="4937109" cy="4903541"/>
            <a:chOff x="5776075" y="628664"/>
            <a:chExt cx="4937109" cy="4903541"/>
          </a:xfrm>
        </p:grpSpPr>
        <p:pic>
          <p:nvPicPr>
            <p:cNvPr id="198" name="Picture 197">
              <a:extLst>
                <a:ext uri="{FF2B5EF4-FFF2-40B4-BE49-F238E27FC236}">
                  <a16:creationId xmlns:a16="http://schemas.microsoft.com/office/drawing/2014/main" id="{A5CB52D0-9A99-EE53-538A-6030005E07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6176" t="1066" r="38" b="-18752"/>
            <a:stretch/>
          </p:blipFill>
          <p:spPr>
            <a:xfrm>
              <a:off x="6545976" y="4207350"/>
              <a:ext cx="3973992" cy="346503"/>
            </a:xfrm>
            <a:prstGeom prst="rect">
              <a:avLst/>
            </a:prstGeom>
            <a:ln>
              <a:noFill/>
            </a:ln>
          </p:spPr>
        </p:pic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7B7524E4-49EA-B101-80D7-3E05B4221B11}"/>
                </a:ext>
              </a:extLst>
            </p:cNvPr>
            <p:cNvSpPr txBox="1"/>
            <p:nvPr/>
          </p:nvSpPr>
          <p:spPr>
            <a:xfrm>
              <a:off x="5776075" y="4194450"/>
              <a:ext cx="707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24B245A9-19A0-09BE-B2FD-4C38AB6C1232}"/>
                </a:ext>
              </a:extLst>
            </p:cNvPr>
            <p:cNvSpPr txBox="1"/>
            <p:nvPr/>
          </p:nvSpPr>
          <p:spPr>
            <a:xfrm>
              <a:off x="5777572" y="3541780"/>
              <a:ext cx="707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WOX</a:t>
              </a:r>
            </a:p>
          </p:txBody>
        </p:sp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0390FC1E-0C59-B474-A519-B848181E3A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0504" t="49117" r="37334" b="29549"/>
            <a:stretch/>
          </p:blipFill>
          <p:spPr>
            <a:xfrm>
              <a:off x="6414429" y="2824681"/>
              <a:ext cx="4105537" cy="1340936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2" name="Picture 201">
              <a:extLst>
                <a:ext uri="{FF2B5EF4-FFF2-40B4-BE49-F238E27FC236}">
                  <a16:creationId xmlns:a16="http://schemas.microsoft.com/office/drawing/2014/main" id="{6EB28461-7260-7E78-DD03-F282A05EDF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39799" t="37568" r="36720" b="42085"/>
            <a:stretch/>
          </p:blipFill>
          <p:spPr>
            <a:xfrm>
              <a:off x="6414429" y="1627799"/>
              <a:ext cx="4094186" cy="11680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E1DF90C2-B5F7-0AFB-BF4D-04C9EE30AE85}"/>
                </a:ext>
              </a:extLst>
            </p:cNvPr>
            <p:cNvSpPr txBox="1"/>
            <p:nvPr/>
          </p:nvSpPr>
          <p:spPr>
            <a:xfrm>
              <a:off x="5888549" y="2185789"/>
              <a:ext cx="646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-Myc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97FA0EC7-AA1A-6B43-EB5D-4111399BC7E5}"/>
                </a:ext>
              </a:extLst>
            </p:cNvPr>
            <p:cNvSpPr txBox="1"/>
            <p:nvPr/>
          </p:nvSpPr>
          <p:spPr>
            <a:xfrm rot="19701933">
              <a:off x="7014568" y="4488642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58EF15F1-650D-20ED-9A65-1D59A1CDE78C}"/>
                </a:ext>
              </a:extLst>
            </p:cNvPr>
            <p:cNvSpPr txBox="1"/>
            <p:nvPr/>
          </p:nvSpPr>
          <p:spPr>
            <a:xfrm rot="19701933">
              <a:off x="7364935" y="4470885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975F7BE5-6B34-5C14-09BD-E534193BC946}"/>
                </a:ext>
              </a:extLst>
            </p:cNvPr>
            <p:cNvSpPr txBox="1"/>
            <p:nvPr/>
          </p:nvSpPr>
          <p:spPr>
            <a:xfrm rot="19701933">
              <a:off x="7600702" y="4497519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5FB7515B-F2EC-2340-EBFA-70B7B26C9B26}"/>
                </a:ext>
              </a:extLst>
            </p:cNvPr>
            <p:cNvSpPr txBox="1"/>
            <p:nvPr/>
          </p:nvSpPr>
          <p:spPr>
            <a:xfrm rot="19701933">
              <a:off x="7925177" y="4488641"/>
              <a:ext cx="640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51BD91B-2B3D-3056-B831-0AB73858C394}"/>
                </a:ext>
              </a:extLst>
            </p:cNvPr>
            <p:cNvSpPr txBox="1"/>
            <p:nvPr/>
          </p:nvSpPr>
          <p:spPr>
            <a:xfrm rot="18589986">
              <a:off x="6753937" y="4891169"/>
              <a:ext cx="9522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KO-yB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9" name="Straight Connector 208">
              <a:extLst>
                <a:ext uri="{FF2B5EF4-FFF2-40B4-BE49-F238E27FC236}">
                  <a16:creationId xmlns:a16="http://schemas.microsoft.com/office/drawing/2014/main" id="{06BD0BBF-0DC9-3CB3-A208-3E4B4DFB3F15}"/>
                </a:ext>
              </a:extLst>
            </p:cNvPr>
            <p:cNvCxnSpPr>
              <a:cxnSpLocks/>
            </p:cNvCxnSpPr>
            <p:nvPr/>
          </p:nvCxnSpPr>
          <p:spPr>
            <a:xfrm>
              <a:off x="7233106" y="4732044"/>
              <a:ext cx="2910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61ADE594-8EE2-E1F5-FCB4-B86735B52C22}"/>
                </a:ext>
              </a:extLst>
            </p:cNvPr>
            <p:cNvSpPr txBox="1"/>
            <p:nvPr/>
          </p:nvSpPr>
          <p:spPr>
            <a:xfrm rot="18589152">
              <a:off x="7275349" y="4932954"/>
              <a:ext cx="9522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KO-yB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1" name="Straight Connector 210">
              <a:extLst>
                <a:ext uri="{FF2B5EF4-FFF2-40B4-BE49-F238E27FC236}">
                  <a16:creationId xmlns:a16="http://schemas.microsoft.com/office/drawing/2014/main" id="{FA070995-2384-EF19-45BA-0432F6FD3BC0}"/>
                </a:ext>
              </a:extLst>
            </p:cNvPr>
            <p:cNvCxnSpPr>
              <a:cxnSpLocks/>
            </p:cNvCxnSpPr>
            <p:nvPr/>
          </p:nvCxnSpPr>
          <p:spPr>
            <a:xfrm>
              <a:off x="7571831" y="4732044"/>
              <a:ext cx="53288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5" name="Picture 214">
              <a:extLst>
                <a:ext uri="{FF2B5EF4-FFF2-40B4-BE49-F238E27FC236}">
                  <a16:creationId xmlns:a16="http://schemas.microsoft.com/office/drawing/2014/main" id="{7429C0B8-03B8-4C8D-37F1-78024B2A55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9857" t="45095" r="39390" b="38888"/>
            <a:stretch/>
          </p:blipFill>
          <p:spPr>
            <a:xfrm>
              <a:off x="6425780" y="628664"/>
              <a:ext cx="4094186" cy="9612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87C896F8-788B-677A-AAC5-ACC0AD134FA4}"/>
                </a:ext>
              </a:extLst>
            </p:cNvPr>
            <p:cNvSpPr txBox="1"/>
            <p:nvPr/>
          </p:nvSpPr>
          <p:spPr>
            <a:xfrm>
              <a:off x="6004053" y="1027097"/>
              <a:ext cx="531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cxnSp>
          <p:nvCxnSpPr>
            <p:cNvPr id="243" name="Straight Arrow Connector 242">
              <a:extLst>
                <a:ext uri="{FF2B5EF4-FFF2-40B4-BE49-F238E27FC236}">
                  <a16:creationId xmlns:a16="http://schemas.microsoft.com/office/drawing/2014/main" id="{13089474-7224-C2CD-2242-5F62987F53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125956" y="3680708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Arrow Connector 243">
              <a:extLst>
                <a:ext uri="{FF2B5EF4-FFF2-40B4-BE49-F238E27FC236}">
                  <a16:creationId xmlns:a16="http://schemas.microsoft.com/office/drawing/2014/main" id="{072F9328-53E2-A619-A04A-1B493B5810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89728" y="2380414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Straight Arrow Connector 244">
              <a:extLst>
                <a:ext uri="{FF2B5EF4-FFF2-40B4-BE49-F238E27FC236}">
                  <a16:creationId xmlns:a16="http://schemas.microsoft.com/office/drawing/2014/main" id="{970F2B90-9167-DF21-B57E-0FF727B8DD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98492" y="1247901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760AE824-B431-15CC-8A07-23B875071B6B}"/>
                </a:ext>
              </a:extLst>
            </p:cNvPr>
            <p:cNvSpPr txBox="1"/>
            <p:nvPr/>
          </p:nvSpPr>
          <p:spPr>
            <a:xfrm>
              <a:off x="5810075" y="1190458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B7A83273-A75A-3001-A90E-0383ACC0847F}"/>
                </a:ext>
              </a:extLst>
            </p:cNvPr>
            <p:cNvSpPr txBox="1"/>
            <p:nvPr/>
          </p:nvSpPr>
          <p:spPr>
            <a:xfrm>
              <a:off x="5851508" y="2340559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2AE3F3C6-6C0A-F92E-3CB1-C5ABF4B2DE19}"/>
                </a:ext>
              </a:extLst>
            </p:cNvPr>
            <p:cNvSpPr txBox="1"/>
            <p:nvPr/>
          </p:nvSpPr>
          <p:spPr>
            <a:xfrm>
              <a:off x="5793512" y="3414759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850D05AF-0442-1BDA-4994-F4B5C8495FAA}"/>
                </a:ext>
              </a:extLst>
            </p:cNvPr>
            <p:cNvSpPr txBox="1"/>
            <p:nvPr/>
          </p:nvSpPr>
          <p:spPr>
            <a:xfrm>
              <a:off x="6189630" y="4060389"/>
              <a:ext cx="83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kDa</a:t>
              </a:r>
            </a:p>
          </p:txBody>
        </p:sp>
        <p:cxnSp>
          <p:nvCxnSpPr>
            <p:cNvPr id="250" name="Straight Arrow Connector 249">
              <a:extLst>
                <a:ext uri="{FF2B5EF4-FFF2-40B4-BE49-F238E27FC236}">
                  <a16:creationId xmlns:a16="http://schemas.microsoft.com/office/drawing/2014/main" id="{4435E5A4-8E8E-1105-C7BD-0BB0ADE6D6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19570" y="4347799"/>
              <a:ext cx="29361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2" name="TextBox 251">
            <a:extLst>
              <a:ext uri="{FF2B5EF4-FFF2-40B4-BE49-F238E27FC236}">
                <a16:creationId xmlns:a16="http://schemas.microsoft.com/office/drawing/2014/main" id="{02CF4F09-B90F-25AE-6DC3-D8D33B4279DB}"/>
              </a:ext>
            </a:extLst>
          </p:cNvPr>
          <p:cNvSpPr txBox="1"/>
          <p:nvPr/>
        </p:nvSpPr>
        <p:spPr>
          <a:xfrm>
            <a:off x="1011919" y="383981"/>
            <a:ext cx="2935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 6G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8461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1</Words>
  <Application>Microsoft Office PowerPoint</Application>
  <PresentationFormat>Widescreen</PresentationFormat>
  <Paragraphs>10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ia Akkawi</dc:creator>
  <cp:lastModifiedBy>Rania Akkawi</cp:lastModifiedBy>
  <cp:revision>2</cp:revision>
  <dcterms:created xsi:type="dcterms:W3CDTF">2023-11-16T07:27:13Z</dcterms:created>
  <dcterms:modified xsi:type="dcterms:W3CDTF">2023-11-16T07:28:26Z</dcterms:modified>
</cp:coreProperties>
</file>